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792" autoAdjust="0"/>
    <p:restoredTop sz="94660"/>
  </p:normalViewPr>
  <p:slideViewPr>
    <p:cSldViewPr snapToGrid="0">
      <p:cViewPr varScale="1">
        <p:scale>
          <a:sx n="101" d="100"/>
          <a:sy n="101" d="100"/>
        </p:scale>
        <p:origin x="1380"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10"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im Butler" userId="ded128e0-3cc6-43d8-8111-013b4f26f0f0" providerId="ADAL" clId="{32FA8032-12F6-42DF-A471-0E0667693F08}"/>
    <pc:docChg chg="custSel modSld">
      <pc:chgData name="Kim Butler" userId="ded128e0-3cc6-43d8-8111-013b4f26f0f0" providerId="ADAL" clId="{32FA8032-12F6-42DF-A471-0E0667693F08}" dt="2026-03-06T22:13:04.279" v="207" actId="6549"/>
      <pc:docMkLst>
        <pc:docMk/>
      </pc:docMkLst>
      <pc:sldChg chg="modSp mod">
        <pc:chgData name="Kim Butler" userId="ded128e0-3cc6-43d8-8111-013b4f26f0f0" providerId="ADAL" clId="{32FA8032-12F6-42DF-A471-0E0667693F08}" dt="2026-03-06T22:13:04.279" v="207" actId="6549"/>
        <pc:sldMkLst>
          <pc:docMk/>
          <pc:sldMk cId="4243777643" sldId="256"/>
        </pc:sldMkLst>
        <pc:spChg chg="mod">
          <ac:chgData name="Kim Butler" userId="ded128e0-3cc6-43d8-8111-013b4f26f0f0" providerId="ADAL" clId="{32FA8032-12F6-42DF-A471-0E0667693F08}" dt="2026-03-06T22:13:04.279" v="207" actId="6549"/>
          <ac:spMkLst>
            <pc:docMk/>
            <pc:sldMk cId="4243777643" sldId="256"/>
            <ac:spMk id="3" creationId="{C46EBDE9-EF46-011C-BF1E-382D0458F542}"/>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1CB9D4-9B84-AA51-C521-97D7E7815BA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0175D6B-2F0B-DB50-7534-B5F12A270D0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7B9BCA7-561F-789E-F252-0F8335AD50FE}"/>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5" name="Footer Placeholder 4">
            <a:extLst>
              <a:ext uri="{FF2B5EF4-FFF2-40B4-BE49-F238E27FC236}">
                <a16:creationId xmlns:a16="http://schemas.microsoft.com/office/drawing/2014/main" id="{76DA0883-4B78-D84E-B258-7B76C2F8D2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D172E5-96C4-D9D8-EF68-097555F7D61E}"/>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27390260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3D1900-1CE2-BE6F-19B2-99FC68D2BC5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0EDA036-6CDD-48C5-AC75-7C2866552BE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15E81DC-B96B-0FA2-3553-42220D5A6446}"/>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5" name="Footer Placeholder 4">
            <a:extLst>
              <a:ext uri="{FF2B5EF4-FFF2-40B4-BE49-F238E27FC236}">
                <a16:creationId xmlns:a16="http://schemas.microsoft.com/office/drawing/2014/main" id="{F23E5298-3256-2E12-43E8-4741D7508EE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4D54B63-F98C-99FF-C65C-21523842EF3B}"/>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9838272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2938E1D-9E70-C0F1-F772-87145824DC3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403C9C7-34D5-6B7F-3A43-8C747753EAA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B79E4F-CFF0-BBF2-C9B8-BCA18ACF115B}"/>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5" name="Footer Placeholder 4">
            <a:extLst>
              <a:ext uri="{FF2B5EF4-FFF2-40B4-BE49-F238E27FC236}">
                <a16:creationId xmlns:a16="http://schemas.microsoft.com/office/drawing/2014/main" id="{00E65313-3B5F-266A-585E-B7C3D821D4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5669EE-4710-12DF-AD1C-E3AB5EB7AA56}"/>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39885848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4D17F1-9B5D-9A3B-000B-1D0B9AF47B2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3A74496-06C2-85C2-6886-9ADA8A8A35F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02004F-90B2-C3EC-938E-447043BB5BAB}"/>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5" name="Footer Placeholder 4">
            <a:extLst>
              <a:ext uri="{FF2B5EF4-FFF2-40B4-BE49-F238E27FC236}">
                <a16:creationId xmlns:a16="http://schemas.microsoft.com/office/drawing/2014/main" id="{37C27553-C406-C29D-E88D-0986DCCE696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85A0EC-CA3A-406E-B0F0-85BD1FBB8A4B}"/>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30866484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857BB4-47E0-AD62-6157-E246BEE0062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B99A92A-F9DC-5133-0D65-9B56F5F808D6}"/>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11A30A4-BF21-1A9C-8F14-E9FC2ECF8BB9}"/>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5" name="Footer Placeholder 4">
            <a:extLst>
              <a:ext uri="{FF2B5EF4-FFF2-40B4-BE49-F238E27FC236}">
                <a16:creationId xmlns:a16="http://schemas.microsoft.com/office/drawing/2014/main" id="{25F32826-11F9-2414-E3CF-9E12AAC01A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F2FB076-969D-5781-ED70-C6B518D0578F}"/>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42070588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D65EDB-5B8E-3605-163C-4789A5E782C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13D0915-6458-B0B8-9FCB-A69CA3FE4F9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63E8E27-158D-F74A-9829-0D95713B3CE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FD5CB49-3BF6-0498-B2AC-06EA59DB48DE}"/>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6" name="Footer Placeholder 5">
            <a:extLst>
              <a:ext uri="{FF2B5EF4-FFF2-40B4-BE49-F238E27FC236}">
                <a16:creationId xmlns:a16="http://schemas.microsoft.com/office/drawing/2014/main" id="{F66097B6-25CF-4C26-22B5-0F310A58BFA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665531-F3CD-E247-1783-8D80BBD6FE79}"/>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10834200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152E73-4AB3-67C2-66F0-59607226D41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0A2DD7B-1C24-D095-DBED-E431BF3068A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79E73AA-C82F-A5D2-1F35-DE46745961E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04BAFC6-D68D-0C13-5B9D-E1860726599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6E7DF6C-A397-47EB-1175-7AE9094D44D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832B900-1692-1CEC-F8AC-6CEE1CA17FD5}"/>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8" name="Footer Placeholder 7">
            <a:extLst>
              <a:ext uri="{FF2B5EF4-FFF2-40B4-BE49-F238E27FC236}">
                <a16:creationId xmlns:a16="http://schemas.microsoft.com/office/drawing/2014/main" id="{4C8E4995-E78A-1A92-459B-209EA486A52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9D16B69-1531-D307-8F8C-B01731BB8989}"/>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40118848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F337F2-FAA7-F5A4-B17A-920961F450E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C61753B-FB1D-2AF1-2F45-1F42250CE562}"/>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4" name="Footer Placeholder 3">
            <a:extLst>
              <a:ext uri="{FF2B5EF4-FFF2-40B4-BE49-F238E27FC236}">
                <a16:creationId xmlns:a16="http://schemas.microsoft.com/office/drawing/2014/main" id="{1950402B-2002-AE8A-86B2-28B716DBAE1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B34C66B-B509-36EE-9B54-D9D710D4B424}"/>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6483906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ED44B8F-5D98-EDE9-3A70-F395EA3CE580}"/>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3" name="Footer Placeholder 2">
            <a:extLst>
              <a:ext uri="{FF2B5EF4-FFF2-40B4-BE49-F238E27FC236}">
                <a16:creationId xmlns:a16="http://schemas.microsoft.com/office/drawing/2014/main" id="{E76A9EAD-69EB-A719-0B14-BE23D3F3805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AE8045C-0580-6EB7-B0C6-C2E0D2B34EED}"/>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25012611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5C3270-3164-D784-2BDF-935E054DAD3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73DA627-7EED-15A2-F79F-1487AEF0942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304DEC5-283A-2C4C-FDA0-68D02313F3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49B6E4B-F67A-0149-D1FF-5E875D8A3F69}"/>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6" name="Footer Placeholder 5">
            <a:extLst>
              <a:ext uri="{FF2B5EF4-FFF2-40B4-BE49-F238E27FC236}">
                <a16:creationId xmlns:a16="http://schemas.microsoft.com/office/drawing/2014/main" id="{360B8326-9A42-E53E-0CCD-A9055325112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957A40E-916D-9FA8-5F9A-2D65AF2F2625}"/>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9092260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D0B85A-156A-A4C4-C313-5ACC16D3EB2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624BD59-4297-1206-7F5E-477295BAC46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ABC8C19-CC97-5DCC-EA74-34006284475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146DE1F-7BFA-6800-1DCD-8C9070DB428D}"/>
              </a:ext>
            </a:extLst>
          </p:cNvPr>
          <p:cNvSpPr>
            <a:spLocks noGrp="1"/>
          </p:cNvSpPr>
          <p:nvPr>
            <p:ph type="dt" sz="half" idx="10"/>
          </p:nvPr>
        </p:nvSpPr>
        <p:spPr/>
        <p:txBody>
          <a:bodyPr/>
          <a:lstStyle/>
          <a:p>
            <a:fld id="{B03D7824-BFD0-49E4-8B2E-595D162FF07C}" type="datetimeFigureOut">
              <a:rPr lang="en-US" smtClean="0"/>
              <a:t>3/6/2026</a:t>
            </a:fld>
            <a:endParaRPr lang="en-US"/>
          </a:p>
        </p:txBody>
      </p:sp>
      <p:sp>
        <p:nvSpPr>
          <p:cNvPr id="6" name="Footer Placeholder 5">
            <a:extLst>
              <a:ext uri="{FF2B5EF4-FFF2-40B4-BE49-F238E27FC236}">
                <a16:creationId xmlns:a16="http://schemas.microsoft.com/office/drawing/2014/main" id="{42684A6C-8B15-DD80-39AF-542DC5BAB84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87519DC-BBE5-6368-7701-17834FDE5746}"/>
              </a:ext>
            </a:extLst>
          </p:cNvPr>
          <p:cNvSpPr>
            <a:spLocks noGrp="1"/>
          </p:cNvSpPr>
          <p:nvPr>
            <p:ph type="sldNum" sz="quarter" idx="12"/>
          </p:nvPr>
        </p:nvSpPr>
        <p:spPr/>
        <p:txBody>
          <a:bodyPr/>
          <a:lstStyle/>
          <a:p>
            <a:fld id="{9204B555-0F05-4858-AA66-D2DD0B25D86E}" type="slidenum">
              <a:rPr lang="en-US" smtClean="0"/>
              <a:t>‹#›</a:t>
            </a:fld>
            <a:endParaRPr lang="en-US"/>
          </a:p>
        </p:txBody>
      </p:sp>
    </p:spTree>
    <p:extLst>
      <p:ext uri="{BB962C8B-B14F-4D97-AF65-F5344CB8AC3E}">
        <p14:creationId xmlns:p14="http://schemas.microsoft.com/office/powerpoint/2010/main" val="28007329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406B1C2-5441-812C-1BF6-99683792DEC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39B88BE-D55B-D757-C6DD-4C92E88DB0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70DB7DC-E70D-CC94-DA9B-6A7B5EE3C83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03D7824-BFD0-49E4-8B2E-595D162FF07C}" type="datetimeFigureOut">
              <a:rPr lang="en-US" smtClean="0"/>
              <a:t>3/6/2026</a:t>
            </a:fld>
            <a:endParaRPr lang="en-US"/>
          </a:p>
        </p:txBody>
      </p:sp>
      <p:sp>
        <p:nvSpPr>
          <p:cNvPr id="5" name="Footer Placeholder 4">
            <a:extLst>
              <a:ext uri="{FF2B5EF4-FFF2-40B4-BE49-F238E27FC236}">
                <a16:creationId xmlns:a16="http://schemas.microsoft.com/office/drawing/2014/main" id="{F5D2B9D4-37EF-4C4F-BFE1-2E50A6E53BD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CDBAE64-D655-6173-AAC3-1A0BC35B469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204B555-0F05-4858-AA66-D2DD0B25D86E}" type="slidenum">
              <a:rPr lang="en-US" smtClean="0"/>
              <a:t>‹#›</a:t>
            </a:fld>
            <a:endParaRPr lang="en-US"/>
          </a:p>
        </p:txBody>
      </p:sp>
    </p:spTree>
    <p:extLst>
      <p:ext uri="{BB962C8B-B14F-4D97-AF65-F5344CB8AC3E}">
        <p14:creationId xmlns:p14="http://schemas.microsoft.com/office/powerpoint/2010/main" val="35657792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ABAC34D-B1FA-5B1F-D90D-97DA69D3E046}"/>
              </a:ext>
            </a:extLst>
          </p:cNvPr>
          <p:cNvGrpSpPr/>
          <p:nvPr/>
        </p:nvGrpSpPr>
        <p:grpSpPr>
          <a:xfrm>
            <a:off x="1264539" y="0"/>
            <a:ext cx="9925050" cy="5400675"/>
            <a:chOff x="1133475" y="728663"/>
            <a:chExt cx="9925050" cy="5400675"/>
          </a:xfrm>
        </p:grpSpPr>
        <p:pic>
          <p:nvPicPr>
            <p:cNvPr id="1026" name="Picture 2">
              <a:extLst>
                <a:ext uri="{FF2B5EF4-FFF2-40B4-BE49-F238E27FC236}">
                  <a16:creationId xmlns:a16="http://schemas.microsoft.com/office/drawing/2014/main" id="{ECEB2A50-4AA6-5AFC-30BE-D12B2FD4796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33475" y="728663"/>
              <a:ext cx="9925050" cy="5400675"/>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3A080F68-AD63-D4BF-49C5-DCA97F18624A}"/>
                </a:ext>
              </a:extLst>
            </p:cNvPr>
            <p:cNvSpPr/>
            <p:nvPr/>
          </p:nvSpPr>
          <p:spPr>
            <a:xfrm>
              <a:off x="5998464" y="841248"/>
              <a:ext cx="1152144" cy="23774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 name="TextBox 2">
            <a:extLst>
              <a:ext uri="{FF2B5EF4-FFF2-40B4-BE49-F238E27FC236}">
                <a16:creationId xmlns:a16="http://schemas.microsoft.com/office/drawing/2014/main" id="{C46EBDE9-EF46-011C-BF1E-382D0458F542}"/>
              </a:ext>
            </a:extLst>
          </p:cNvPr>
          <p:cNvSpPr txBox="1"/>
          <p:nvPr/>
        </p:nvSpPr>
        <p:spPr>
          <a:xfrm>
            <a:off x="1014984" y="5619623"/>
            <a:ext cx="10424160"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l Figure 1: Assessment of immune activation by candidate ASOs in BJAB cells using CCL22 mRNA as a surrogate marker.</a:t>
            </a:r>
          </a:p>
          <a:p>
            <a:r>
              <a:rPr lang="en-US" sz="1200" dirty="0">
                <a:latin typeface="Arial" panose="020B0604020202020204" pitchFamily="34" charset="0"/>
                <a:cs typeface="Arial" panose="020B0604020202020204" pitchFamily="34" charset="0"/>
              </a:rPr>
              <a:t>CCL22 mRNA levels were quantified by qPCR in BJAB cells 24 hours after treatment with 1.6 µM antisense oligonucleotides (ASOs), including candidate and benchmark ASOs. CCL22 expression was determined by RTPCR normalized to </a:t>
            </a:r>
            <a:r>
              <a:rPr lang="en-US" sz="1200" dirty="0" err="1">
                <a:latin typeface="Arial" panose="020B0604020202020204" pitchFamily="34" charset="0"/>
                <a:cs typeface="Arial" panose="020B0604020202020204" pitchFamily="34" charset="0"/>
              </a:rPr>
              <a:t>Ribogreen</a:t>
            </a:r>
            <a:r>
              <a:rPr lang="en-US" sz="1200" dirty="0">
                <a:latin typeface="Arial" panose="020B0604020202020204" pitchFamily="34" charset="0"/>
                <a:cs typeface="Arial" panose="020B0604020202020204" pitchFamily="34" charset="0"/>
              </a:rPr>
              <a:t> in untreated control cells (UTC), and divided into CCL22 expression levels in ASO treated cells. Based on their relative expression of CCL22 compared to UTC and benchmark ASOs, candidates were categorized as inflammatory, cautious, or safe (dashed thresholds). </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4377764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450265C1EB5D440A6DAB34664AFFC48" ma:contentTypeVersion="15" ma:contentTypeDescription="Create a new document." ma:contentTypeScope="" ma:versionID="5278df8b7f4aaeaf010986cd9aca1ce0">
  <xsd:schema xmlns:xsd="http://www.w3.org/2001/XMLSchema" xmlns:xs="http://www.w3.org/2001/XMLSchema" xmlns:p="http://schemas.microsoft.com/office/2006/metadata/properties" xmlns:ns2="127c9a63-9646-4cb2-a818-90671d3f9c1a" xmlns:ns3="14bd43aa-9200-4150-b171-853216ff02b4" targetNamespace="http://schemas.microsoft.com/office/2006/metadata/properties" ma:root="true" ma:fieldsID="8eb7c2db56029bca62307543672dffdc" ns2:_="" ns3:_="">
    <xsd:import namespace="127c9a63-9646-4cb2-a818-90671d3f9c1a"/>
    <xsd:import namespace="14bd43aa-9200-4150-b171-853216ff02b4"/>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ObjectDetectorVersions" minOccurs="0"/>
                <xsd:element ref="ns2:MediaServiceSearchProperties" minOccurs="0"/>
                <xsd:element ref="ns2:MediaServiceGenerationTime" minOccurs="0"/>
                <xsd:element ref="ns2:MediaServiceEventHashCode" minOccurs="0"/>
                <xsd:element ref="ns2:MediaLengthInSeconds" minOccurs="0"/>
                <xsd:element ref="ns2:MediaServiceDateTaken" minOccurs="0"/>
                <xsd:element ref="ns2:MediaServiceBillingMetadata" minOccurs="0"/>
                <xsd:element ref="ns2:lcf76f155ced4ddcb4097134ff3c332f" minOccurs="0"/>
                <xsd:element ref="ns3:TaxCatchAll" minOccurs="0"/>
                <xsd:element ref="ns2: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27c9a63-9646-4cb2-a818-90671d3f9c1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2" nillable="true" ma:displayName="MediaServiceObjectDetectorVersions" ma:hidden="true" ma:indexed="true" ma:internalName="MediaServiceObjectDetectorVersions" ma:readOnly="true">
      <xsd:simpleType>
        <xsd:restriction base="dms:Text"/>
      </xsd:simpleType>
    </xsd:element>
    <xsd:element name="MediaServiceSearchProperties" ma:index="13" nillable="true" ma:displayName="MediaServiceSearchProperties" ma:hidden="true" ma:internalName="MediaServiceSearchProperties" ma:readOnly="true">
      <xsd:simpleType>
        <xsd:restriction base="dms:Note"/>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LengthInSeconds" ma:index="16" nillable="true" ma:displayName="MediaLengthInSeconds" ma:hidden="true" ma:internalName="MediaLengthInSeconds" ma:readOnly="true">
      <xsd:simpleType>
        <xsd:restriction base="dms:Unknown"/>
      </xsd:simpleType>
    </xsd:element>
    <xsd:element name="MediaServiceDateTaken" ma:index="17" nillable="true" ma:displayName="MediaServiceDateTaken" ma:hidden="true" ma:indexed="true" ma:internalName="MediaServiceDateTaken" ma:readOnly="true">
      <xsd:simpleType>
        <xsd:restriction base="dms:Text"/>
      </xsd:simpleType>
    </xsd:element>
    <xsd:element name="MediaServiceBillingMetadata" ma:index="18" nillable="true" ma:displayName="MediaServiceBillingMetadata" ma:hidden="true" ma:internalName="MediaServiceBillingMetadata" ma:readOnly="true">
      <xsd:simpleType>
        <xsd:restriction base="dms:Note"/>
      </xsd:simpleType>
    </xsd:element>
    <xsd:element name="lcf76f155ced4ddcb4097134ff3c332f" ma:index="20" nillable="true" ma:taxonomy="true" ma:internalName="lcf76f155ced4ddcb4097134ff3c332f" ma:taxonomyFieldName="MediaServiceImageTags" ma:displayName="Image Tags" ma:readOnly="false" ma:fieldId="{5cf76f15-5ced-4ddc-b409-7134ff3c332f}" ma:taxonomyMulti="true" ma:sspId="e44e48d3-2400-4996-a179-5e96f7ccd141" ma:termSetId="09814cd3-568e-fe90-9814-8d621ff8fb84" ma:anchorId="fba54fb3-c3e1-fe81-a776-ca4b69148c4d" ma:open="true" ma:isKeyword="false">
      <xsd:complexType>
        <xsd:sequence>
          <xsd:element ref="pc:Terms" minOccurs="0" maxOccurs="1"/>
        </xsd:sequence>
      </xsd:complexType>
    </xsd:element>
    <xsd:element name="MediaServiceOCR" ma:index="22"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14bd43aa-9200-4150-b171-853216ff02b4"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21" nillable="true" ma:displayName="Taxonomy Catch All Column" ma:hidden="true" ma:list="{b4f98509-8e4e-4fd5-bec7-f9036a95d4ce}" ma:internalName="TaxCatchAll" ma:showField="CatchAllData" ma:web="14bd43aa-9200-4150-b171-853216ff02b4">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127c9a63-9646-4cb2-a818-90671d3f9c1a">
      <Terms xmlns="http://schemas.microsoft.com/office/infopath/2007/PartnerControls"/>
    </lcf76f155ced4ddcb4097134ff3c332f>
    <TaxCatchAll xmlns="14bd43aa-9200-4150-b171-853216ff02b4" xsi:nil="true"/>
  </documentManagement>
</p:properties>
</file>

<file path=customXml/itemProps1.xml><?xml version="1.0" encoding="utf-8"?>
<ds:datastoreItem xmlns:ds="http://schemas.openxmlformats.org/officeDocument/2006/customXml" ds:itemID="{8AA24B63-039E-4637-9C1D-E8ABD76EBCA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27c9a63-9646-4cb2-a818-90671d3f9c1a"/>
    <ds:schemaRef ds:uri="14bd43aa-9200-4150-b171-853216ff02b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FDF45BB2-2552-4D39-B552-BCA9E4700252}">
  <ds:schemaRefs>
    <ds:schemaRef ds:uri="http://schemas.microsoft.com/sharepoint/v3/contenttype/forms"/>
  </ds:schemaRefs>
</ds:datastoreItem>
</file>

<file path=customXml/itemProps3.xml><?xml version="1.0" encoding="utf-8"?>
<ds:datastoreItem xmlns:ds="http://schemas.openxmlformats.org/officeDocument/2006/customXml" ds:itemID="{E5CFDFD8-E263-422E-B54B-61D630DB887A}">
  <ds:schemaRefs>
    <ds:schemaRef ds:uri="http://schemas.microsoft.com/office/2006/metadata/properties"/>
    <ds:schemaRef ds:uri="http://schemas.microsoft.com/office/infopath/2007/PartnerControls"/>
    <ds:schemaRef ds:uri="127c9a63-9646-4cb2-a818-90671d3f9c1a"/>
    <ds:schemaRef ds:uri="14bd43aa-9200-4150-b171-853216ff02b4"/>
  </ds:schemaRefs>
</ds:datastoreItem>
</file>

<file path=docProps/app.xml><?xml version="1.0" encoding="utf-8"?>
<Properties xmlns="http://schemas.openxmlformats.org/officeDocument/2006/extended-properties" xmlns:vt="http://schemas.openxmlformats.org/officeDocument/2006/docPropsVTypes">
  <TotalTime>284</TotalTime>
  <Words>105</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onstantina Skourti-Stathaki</dc:creator>
  <cp:lastModifiedBy>Stan Crooke, KB</cp:lastModifiedBy>
  <cp:revision>2</cp:revision>
  <dcterms:created xsi:type="dcterms:W3CDTF">2026-03-05T20:16:49Z</dcterms:created>
  <dcterms:modified xsi:type="dcterms:W3CDTF">2026-03-06T22:13: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450265C1EB5D440A6DAB34664AFFC48</vt:lpwstr>
  </property>
  <property fmtid="{D5CDD505-2E9C-101B-9397-08002B2CF9AE}" pid="3" name="MediaServiceImageTags">
    <vt:lpwstr/>
  </property>
</Properties>
</file>